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notesSlides/notesSlide18.xml" ContentType="application/vnd.openxmlformats-officedocument.presentationml.notesSlid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0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3.xml" ContentType="application/vnd.openxmlformats-officedocument.presentationml.notes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9.xml" ContentType="application/vnd.openxmlformats-officedocument.presentationml.notes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Layouts/slideLayout3.xml" ContentType="application/vnd.openxmlformats-officedocument.presentationml.slideLayout+xml"/>
  <Override PartName="/ppt/notesSlides/notesSlide17.xml" ContentType="application/vnd.openxmlformats-officedocument.presentationml.notesSlide+xml"/>
  <Default Extension="jpeg" ContentType="image/jpe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66667" autoAdjust="0"/>
  </p:normalViewPr>
  <p:slideViewPr>
    <p:cSldViewPr>
      <p:cViewPr>
        <p:scale>
          <a:sx n="60" d="100"/>
          <a:sy n="60" d="100"/>
        </p:scale>
        <p:origin x="-1572" y="27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6EAC0D-FAC5-4BBB-884B-7A90EBBFC7BC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1F3736-C0FD-4D27-987D-D3D488C2E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376567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81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13445225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ULSSR258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0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25075625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oSo-157-2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44100749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36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59005517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1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06399462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ULSSR85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382995360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ULSSR96B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5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213080944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10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75383057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89A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7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345788391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107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8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524820682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82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9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9486658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oSO340-2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735018580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20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20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2216512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87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73771254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oSo288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35740746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ULSSR253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5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85470679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2SSR112A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50837150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 smtClean="0"/>
              <a:t>MULSSR26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DF8801-6853-45DF-A6E1-BBFB586B2807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7249251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baseline="0" dirty="0" smtClean="0"/>
              <a:t>M2SSR68</a:t>
            </a:r>
            <a:endParaRPr lang="en-US" b="1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DF8801-6853-45DF-A6E1-BBFB586B2807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9117160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/>
              <a:t>MULSSR313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1. Dharatwala, 2. Madhopur-1, 3. Hairythick, 4. M. laevigata (Hybrid), 5. </a:t>
            </a:r>
            <a:r>
              <a:rPr lang="en-US" dirty="0" err="1" smtClean="0"/>
              <a:t>M.lhouseringe</a:t>
            </a:r>
            <a:r>
              <a:rPr lang="en-US" dirty="0" smtClean="0"/>
              <a:t>, 6. Kokuso-20, 7. Belona, 8. Jai Ram </a:t>
            </a:r>
            <a:r>
              <a:rPr lang="en-US" dirty="0" err="1" smtClean="0"/>
              <a:t>Sanehi</a:t>
            </a:r>
            <a:r>
              <a:rPr lang="en-US" dirty="0" smtClean="0"/>
              <a:t> </a:t>
            </a:r>
            <a:r>
              <a:rPr lang="en-US" dirty="0" err="1" smtClean="0"/>
              <a:t>Bagichi</a:t>
            </a:r>
            <a:r>
              <a:rPr lang="en-US" dirty="0" smtClean="0"/>
              <a:t> </a:t>
            </a:r>
            <a:r>
              <a:rPr lang="en-US" dirty="0" err="1" smtClean="0"/>
              <a:t>Uj</a:t>
            </a:r>
            <a:r>
              <a:rPr lang="en-US" dirty="0" smtClean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 smtClean="0"/>
              <a:t>Keeraithodu</a:t>
            </a:r>
            <a:r>
              <a:rPr lang="en-US" dirty="0" smtClean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9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757996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 cstate="print"/>
          <a:srcRect l="11026" r="5897" b="28267"/>
          <a:stretch>
            <a:fillRect/>
          </a:stretch>
        </p:blipFill>
        <p:spPr bwMode="auto">
          <a:xfrm>
            <a:off x="381000" y="228600"/>
            <a:ext cx="7848600" cy="4648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tangle 7"/>
          <p:cNvSpPr/>
          <p:nvPr/>
        </p:nvSpPr>
        <p:spPr>
          <a:xfrm>
            <a:off x="457200" y="2286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57200" y="25146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37 38 39 40 41 42 43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8974" r="7949" b="34450"/>
          <a:stretch>
            <a:fillRect/>
          </a:stretch>
        </p:blipFill>
        <p:spPr bwMode="auto">
          <a:xfrm>
            <a:off x="533400" y="762000"/>
            <a:ext cx="79248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6858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 1   2   3    4   5   6   7   8     9  10  11 12  13 14 15    L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096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  37 38 39 40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3" cstate="print"/>
          <a:srcRect l="7179" r="8718" b="34146"/>
          <a:stretch>
            <a:fillRect/>
          </a:stretch>
        </p:blipFill>
        <p:spPr bwMode="auto">
          <a:xfrm>
            <a:off x="609600" y="990600"/>
            <a:ext cx="79248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Rectangle 9"/>
          <p:cNvSpPr/>
          <p:nvPr/>
        </p:nvSpPr>
        <p:spPr>
          <a:xfrm>
            <a:off x="685800" y="9144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1   2   3    4   5   6   7   8     9  10  11 12  L   13 14 15 16 17 18 19 20 21 22 23 24  25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6858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26 27 28 29 30 31 32 33 34  35  36 37  38 39 40   L  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11026" r="4872" b="30029"/>
          <a:stretch>
            <a:fillRect/>
          </a:stretch>
        </p:blipFill>
        <p:spPr bwMode="auto">
          <a:xfrm>
            <a:off x="533400" y="685800"/>
            <a:ext cx="78486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6858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09600" y="28956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37 38 39 40 41 42 43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3" cstate="print"/>
          <a:srcRect l="8974" t="34359" r="7949" b="49689"/>
          <a:stretch>
            <a:fillRect/>
          </a:stretch>
        </p:blipFill>
        <p:spPr bwMode="auto">
          <a:xfrm>
            <a:off x="533400" y="2362200"/>
            <a:ext cx="7924800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8974" r="7949" b="87729"/>
          <a:stretch>
            <a:fillRect/>
          </a:stretch>
        </p:blipFill>
        <p:spPr bwMode="auto">
          <a:xfrm>
            <a:off x="533400" y="914400"/>
            <a:ext cx="7924800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533400" y="8382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096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  37 38 39 40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11026" r="6923" b="32131"/>
          <a:stretch>
            <a:fillRect/>
          </a:stretch>
        </p:blipFill>
        <p:spPr bwMode="auto">
          <a:xfrm>
            <a:off x="609600" y="838199"/>
            <a:ext cx="7924800" cy="42672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85800" y="7620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7620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  37 38 39 40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5897" r="11026" b="31769"/>
          <a:stretch>
            <a:fillRect/>
          </a:stretch>
        </p:blipFill>
        <p:spPr bwMode="auto">
          <a:xfrm>
            <a:off x="457200" y="838199"/>
            <a:ext cx="7924800" cy="41910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457200" y="7620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5334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  37 38 39 40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lum contrast="40000"/>
          </a:blip>
          <a:srcRect l="8974" r="7949" b="44304"/>
          <a:stretch>
            <a:fillRect/>
          </a:stretch>
        </p:blipFill>
        <p:spPr bwMode="auto">
          <a:xfrm>
            <a:off x="609600" y="990600"/>
            <a:ext cx="7848600" cy="335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9144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85800" y="27432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  37 38 39 40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10000" r="7949" b="32076"/>
          <a:stretch>
            <a:fillRect/>
          </a:stretch>
        </p:blipFill>
        <p:spPr bwMode="auto">
          <a:xfrm>
            <a:off x="533400" y="761999"/>
            <a:ext cx="7772400" cy="4038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533400" y="8382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096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  37 38 39 40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6923" r="10000" b="35443"/>
          <a:stretch>
            <a:fillRect/>
          </a:stretch>
        </p:blipFill>
        <p:spPr bwMode="auto">
          <a:xfrm>
            <a:off x="533400" y="838200"/>
            <a:ext cx="7848600" cy="3886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533400" y="7620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09600" y="25908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  37 38 39 40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5897" r="10000"/>
          <a:stretch>
            <a:fillRect/>
          </a:stretch>
        </p:blipFill>
        <p:spPr bwMode="auto">
          <a:xfrm>
            <a:off x="533400" y="914400"/>
            <a:ext cx="79248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990599"/>
            <a:ext cx="77724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1    2   3   4    5   6    7    8   9  10 11 12   L  13 14 15 16 17 18 19 20 21 22 23 24 25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85800" y="3047999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26 27 28 29 30 31 32 33 34 35  36   37 38 39 40  L   41 42 43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lum contrast="40000"/>
          </a:blip>
          <a:srcRect l="5897" r="11026" b="33275"/>
          <a:stretch>
            <a:fillRect/>
          </a:stretch>
        </p:blipFill>
        <p:spPr bwMode="auto">
          <a:xfrm>
            <a:off x="533400" y="762000"/>
            <a:ext cx="7888192" cy="449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85800" y="762000"/>
            <a:ext cx="77724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1   2   3   4   5   6   7   8     9  10  11 12   13 14 15 16 L   17 18 19 20 21 22 23  24 25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85800" y="32004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6 27 28 29 30 31 32 33 34 35  36   37   38 39 40 41 42 43 44 45 46 47 48 49   L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6923" t="48606" r="8974" b="30488"/>
          <a:stretch>
            <a:fillRect/>
          </a:stretch>
        </p:blipFill>
        <p:spPr bwMode="auto">
          <a:xfrm>
            <a:off x="533400" y="2514600"/>
            <a:ext cx="7914640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 cstate="print"/>
          <a:srcRect l="6923" r="8974" b="75087"/>
          <a:stretch>
            <a:fillRect/>
          </a:stretch>
        </p:blipFill>
        <p:spPr bwMode="auto">
          <a:xfrm>
            <a:off x="533400" y="838200"/>
            <a:ext cx="7924800" cy="1727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Rectangle 6"/>
          <p:cNvSpPr/>
          <p:nvPr/>
        </p:nvSpPr>
        <p:spPr>
          <a:xfrm>
            <a:off x="685800" y="914400"/>
            <a:ext cx="77724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1   2   3   4   5   6   7   8     9  10  11 12    L  13 14 15 16 17 18 19 20 21 22 23  24 25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85800" y="24384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6 27 28 29 30 31 32 33 34 35  36   37 L   38 39 40 41 42 43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lum contrast="-20000"/>
          </a:blip>
          <a:srcRect l="10256" r="7692" b="35633"/>
          <a:stretch>
            <a:fillRect/>
          </a:stretch>
        </p:blipFill>
        <p:spPr bwMode="auto">
          <a:xfrm>
            <a:off x="609600" y="838438"/>
            <a:ext cx="7696200" cy="4266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8382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1   2   3    4   5   6   7   8     9  10  11 12 13 14 15  L 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09600" y="30480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37  L   38 39 40 41 42 43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7949" t="-174" r="8974" b="32672"/>
          <a:stretch>
            <a:fillRect/>
          </a:stretch>
        </p:blipFill>
        <p:spPr bwMode="auto">
          <a:xfrm>
            <a:off x="685800" y="838200"/>
            <a:ext cx="7696200" cy="44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85800" y="8382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85800" y="30480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37 38 39 40 41 42 43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 cstate="print">
            <a:lum bright="-10000" contrast="32000"/>
          </a:blip>
          <a:srcRect l="8974" r="6923" b="31664"/>
          <a:stretch>
            <a:fillRect/>
          </a:stretch>
        </p:blipFill>
        <p:spPr bwMode="auto">
          <a:xfrm>
            <a:off x="609600" y="990600"/>
            <a:ext cx="7772400" cy="4419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Rectangle 8"/>
          <p:cNvSpPr/>
          <p:nvPr/>
        </p:nvSpPr>
        <p:spPr>
          <a:xfrm>
            <a:off x="609600" y="990601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85800" y="3352801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37 38 39 40 41 42 43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10000" r="5897" b="37444"/>
          <a:stretch>
            <a:fillRect/>
          </a:stretch>
        </p:blipFill>
        <p:spPr bwMode="auto">
          <a:xfrm>
            <a:off x="533400" y="838199"/>
            <a:ext cx="7848600" cy="39624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7620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 1   2   3    4   5   6   7   8     9  10  11 12    L 13 14 15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096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  37 38 39 40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/>
          <a:srcRect l="6505" t="2870" r="11026" b="29126"/>
          <a:stretch>
            <a:fillRect/>
          </a:stretch>
        </p:blipFill>
        <p:spPr bwMode="auto">
          <a:xfrm>
            <a:off x="762000" y="762000"/>
            <a:ext cx="7696200" cy="4670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Rectangle 4"/>
          <p:cNvSpPr/>
          <p:nvPr/>
        </p:nvSpPr>
        <p:spPr>
          <a:xfrm>
            <a:off x="762000" y="860154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762000" y="3222354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L  37 38 39 40 41 42 43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6358" r="10983" b="29966"/>
          <a:stretch>
            <a:fillRect/>
          </a:stretch>
        </p:blipFill>
        <p:spPr bwMode="auto">
          <a:xfrm>
            <a:off x="685800" y="703800"/>
            <a:ext cx="7676000" cy="463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85800" y="6096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85800" y="27432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L  37 38 39 40 41 42 43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lum contrast="10000"/>
          </a:blip>
          <a:srcRect l="10000" r="7949" b="35948"/>
          <a:stretch>
            <a:fillRect/>
          </a:stretch>
        </p:blipFill>
        <p:spPr bwMode="auto">
          <a:xfrm>
            <a:off x="533400" y="990600"/>
            <a:ext cx="79248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9144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  <a:endParaRPr lang="en-IN" b="1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09600" y="27432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 smtClean="0">
                <a:solidFill>
                  <a:schemeClr val="bg1"/>
                </a:solidFill>
              </a:rPr>
              <a:t>25 26 27 28 29 30 31 32 33 34 35  36    L    37 38 39 40 41 42 43  44 45 46 47 48 49</a:t>
            </a:r>
            <a:endParaRPr lang="en-IN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422</Words>
  <Application>Microsoft Office PowerPoint</Application>
  <PresentationFormat>On-screen Show (4:3)</PresentationFormat>
  <Paragraphs>100</Paragraphs>
  <Slides>20</Slides>
  <Notes>2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oj</dc:creator>
  <cp:lastModifiedBy>admin</cp:lastModifiedBy>
  <cp:revision>1</cp:revision>
  <dcterms:created xsi:type="dcterms:W3CDTF">2006-08-16T00:00:00Z</dcterms:created>
  <dcterms:modified xsi:type="dcterms:W3CDTF">2023-01-24T10:29:36Z</dcterms:modified>
</cp:coreProperties>
</file>